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782" r:id="rId2"/>
    <p:sldId id="781" r:id="rId3"/>
    <p:sldId id="270" r:id="rId4"/>
    <p:sldId id="776" r:id="rId5"/>
    <p:sldId id="777" r:id="rId6"/>
    <p:sldId id="277" r:id="rId7"/>
    <p:sldId id="783" r:id="rId8"/>
    <p:sldId id="784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drigo Costa" initials="RC" lastIdx="2" clrIdx="0">
    <p:extLst>
      <p:ext uri="{19B8F6BF-5375-455C-9EA6-DF929625EA0E}">
        <p15:presenceInfo xmlns:p15="http://schemas.microsoft.com/office/powerpoint/2012/main" userId="b0e7881e604dd4b8" providerId="Windows Live"/>
      </p:ext>
    </p:extLst>
  </p:cmAuthor>
  <p:cmAuthor id="2" name="吉武　和敏" initials="吉武　和敏" lastIdx="2" clrIdx="1">
    <p:extLst>
      <p:ext uri="{19B8F6BF-5375-455C-9EA6-DF929625EA0E}">
        <p15:presenceInfo xmlns:p15="http://schemas.microsoft.com/office/powerpoint/2012/main" userId="S::4981384182@utac.u-tokyo.ac.jp::88860439-fb8d-4bb8-88ca-81141380f531" providerId="AD"/>
      </p:ext>
    </p:extLst>
  </p:cmAuthor>
  <p:cmAuthor id="3" name="Kazutoshi Yoshitake" initials="KY" lastIdx="4" clrIdx="2">
    <p:extLst>
      <p:ext uri="{19B8F6BF-5375-455C-9EA6-DF929625EA0E}">
        <p15:presenceInfo xmlns:p15="http://schemas.microsoft.com/office/powerpoint/2012/main" userId="Kazutoshi Yoshitak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6197"/>
  </p:normalViewPr>
  <p:slideViewPr>
    <p:cSldViewPr snapToGrid="0">
      <p:cViewPr varScale="1">
        <p:scale>
          <a:sx n="119" d="100"/>
          <a:sy n="119" d="100"/>
        </p:scale>
        <p:origin x="11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吉武 和敏" userId="e4825ba96748af9c" providerId="LiveId" clId="{CD5F706F-046B-4764-8521-85C07F58FCCA}"/>
    <pc:docChg chg="undo custSel modSld">
      <pc:chgData name="吉武 和敏" userId="e4825ba96748af9c" providerId="LiveId" clId="{CD5F706F-046B-4764-8521-85C07F58FCCA}" dt="2021-01-25T07:02:02.592" v="136" actId="20577"/>
      <pc:docMkLst>
        <pc:docMk/>
      </pc:docMkLst>
      <pc:sldChg chg="modSp mod">
        <pc:chgData name="吉武 和敏" userId="e4825ba96748af9c" providerId="LiveId" clId="{CD5F706F-046B-4764-8521-85C07F58FCCA}" dt="2021-01-25T07:02:02.592" v="136" actId="20577"/>
        <pc:sldMkLst>
          <pc:docMk/>
          <pc:sldMk cId="4253877532" sldId="270"/>
        </pc:sldMkLst>
        <pc:spChg chg="mod">
          <ac:chgData name="吉武 和敏" userId="e4825ba96748af9c" providerId="LiveId" clId="{CD5F706F-046B-4764-8521-85C07F58FCCA}" dt="2021-01-25T05:53:05.595" v="41" actId="20577"/>
          <ac:spMkLst>
            <pc:docMk/>
            <pc:sldMk cId="4253877532" sldId="270"/>
            <ac:spMk id="9" creationId="{BE6A90BB-2869-46DD-B456-FF04DCEB8C23}"/>
          </ac:spMkLst>
        </pc:spChg>
        <pc:graphicFrameChg chg="mod modGraphic">
          <ac:chgData name="吉武 和敏" userId="e4825ba96748af9c" providerId="LiveId" clId="{CD5F706F-046B-4764-8521-85C07F58FCCA}" dt="2021-01-25T07:02:02.592" v="136" actId="20577"/>
          <ac:graphicFrameMkLst>
            <pc:docMk/>
            <pc:sldMk cId="4253877532" sldId="270"/>
            <ac:graphicFrameMk id="2" creationId="{FF9B6FE1-802B-403B-9507-E201D108CDA6}"/>
          </ac:graphicFrameMkLst>
        </pc:graphicFrameChg>
      </pc:sldChg>
      <pc:sldChg chg="modSp mod">
        <pc:chgData name="吉武 和敏" userId="e4825ba96748af9c" providerId="LiveId" clId="{CD5F706F-046B-4764-8521-85C07F58FCCA}" dt="2021-01-25T05:59:16.350" v="122" actId="20577"/>
        <pc:sldMkLst>
          <pc:docMk/>
          <pc:sldMk cId="1463506978" sldId="277"/>
        </pc:sldMkLst>
        <pc:spChg chg="mod">
          <ac:chgData name="吉武 和敏" userId="e4825ba96748af9c" providerId="LiveId" clId="{CD5F706F-046B-4764-8521-85C07F58FCCA}" dt="2021-01-25T05:57:26.396" v="118" actId="113"/>
          <ac:spMkLst>
            <pc:docMk/>
            <pc:sldMk cId="1463506978" sldId="277"/>
            <ac:spMk id="8" creationId="{00000000-0000-0000-0000-000000000000}"/>
          </ac:spMkLst>
        </pc:spChg>
        <pc:spChg chg="mod">
          <ac:chgData name="吉武 和敏" userId="e4825ba96748af9c" providerId="LiveId" clId="{CD5F706F-046B-4764-8521-85C07F58FCCA}" dt="2021-01-25T05:59:10.831" v="119" actId="20577"/>
          <ac:spMkLst>
            <pc:docMk/>
            <pc:sldMk cId="1463506978" sldId="277"/>
            <ac:spMk id="9" creationId="{00000000-0000-0000-0000-000000000000}"/>
          </ac:spMkLst>
        </pc:spChg>
        <pc:spChg chg="mod">
          <ac:chgData name="吉武 和敏" userId="e4825ba96748af9c" providerId="LiveId" clId="{CD5F706F-046B-4764-8521-85C07F58FCCA}" dt="2021-01-25T05:59:13.199" v="120" actId="20577"/>
          <ac:spMkLst>
            <pc:docMk/>
            <pc:sldMk cId="1463506978" sldId="277"/>
            <ac:spMk id="10" creationId="{00000000-0000-0000-0000-000000000000}"/>
          </ac:spMkLst>
        </pc:spChg>
        <pc:spChg chg="mod">
          <ac:chgData name="吉武 和敏" userId="e4825ba96748af9c" providerId="LiveId" clId="{CD5F706F-046B-4764-8521-85C07F58FCCA}" dt="2021-01-25T05:59:14.958" v="121" actId="20577"/>
          <ac:spMkLst>
            <pc:docMk/>
            <pc:sldMk cId="1463506978" sldId="277"/>
            <ac:spMk id="15" creationId="{00000000-0000-0000-0000-000000000000}"/>
          </ac:spMkLst>
        </pc:spChg>
        <pc:spChg chg="mod">
          <ac:chgData name="吉武 和敏" userId="e4825ba96748af9c" providerId="LiveId" clId="{CD5F706F-046B-4764-8521-85C07F58FCCA}" dt="2021-01-25T05:59:16.350" v="122" actId="20577"/>
          <ac:spMkLst>
            <pc:docMk/>
            <pc:sldMk cId="1463506978" sldId="277"/>
            <ac:spMk id="16" creationId="{00000000-0000-0000-0000-000000000000}"/>
          </ac:spMkLst>
        </pc:spChg>
        <pc:graphicFrameChg chg="modGraphic">
          <ac:chgData name="吉武 和敏" userId="e4825ba96748af9c" providerId="LiveId" clId="{CD5F706F-046B-4764-8521-85C07F58FCCA}" dt="2021-01-25T05:54:44.906" v="73" actId="20577"/>
          <ac:graphicFrameMkLst>
            <pc:docMk/>
            <pc:sldMk cId="1463506978" sldId="277"/>
            <ac:graphicFrameMk id="3" creationId="{513D3A4F-FE27-4D67-B6E1-D1CEE87A0658}"/>
          </ac:graphicFrameMkLst>
        </pc:graphicFrameChg>
      </pc:sldChg>
      <pc:sldChg chg="modSp mod">
        <pc:chgData name="吉武 和敏" userId="e4825ba96748af9c" providerId="LiveId" clId="{CD5F706F-046B-4764-8521-85C07F58FCCA}" dt="2021-01-25T05:53:10.331" v="42" actId="20577"/>
        <pc:sldMkLst>
          <pc:docMk/>
          <pc:sldMk cId="2871958175" sldId="776"/>
        </pc:sldMkLst>
        <pc:spChg chg="mod">
          <ac:chgData name="吉武 和敏" userId="e4825ba96748af9c" providerId="LiveId" clId="{CD5F706F-046B-4764-8521-85C07F58FCCA}" dt="2021-01-25T05:53:10.331" v="42" actId="20577"/>
          <ac:spMkLst>
            <pc:docMk/>
            <pc:sldMk cId="2871958175" sldId="776"/>
            <ac:spMk id="9" creationId="{BE6A90BB-2869-46DD-B456-FF04DCEB8C23}"/>
          </ac:spMkLst>
        </pc:spChg>
        <pc:graphicFrameChg chg="mod modGraphic">
          <ac:chgData name="吉武 和敏" userId="e4825ba96748af9c" providerId="LiveId" clId="{CD5F706F-046B-4764-8521-85C07F58FCCA}" dt="2021-01-25T05:52:36.134" v="36"/>
          <ac:graphicFrameMkLst>
            <pc:docMk/>
            <pc:sldMk cId="2871958175" sldId="776"/>
            <ac:graphicFrameMk id="3" creationId="{F1E5A4E6-A009-421F-BE31-E2D3F1671D91}"/>
          </ac:graphicFrameMkLst>
        </pc:graphicFrameChg>
      </pc:sldChg>
      <pc:sldChg chg="modSp mod">
        <pc:chgData name="吉武 和敏" userId="e4825ba96748af9c" providerId="LiveId" clId="{CD5F706F-046B-4764-8521-85C07F58FCCA}" dt="2021-01-25T05:53:51.761" v="67" actId="20577"/>
        <pc:sldMkLst>
          <pc:docMk/>
          <pc:sldMk cId="1875627820" sldId="777"/>
        </pc:sldMkLst>
        <pc:spChg chg="mod">
          <ac:chgData name="吉武 和敏" userId="e4825ba96748af9c" providerId="LiveId" clId="{CD5F706F-046B-4764-8521-85C07F58FCCA}" dt="2021-01-25T05:53:15.084" v="43" actId="20577"/>
          <ac:spMkLst>
            <pc:docMk/>
            <pc:sldMk cId="1875627820" sldId="777"/>
            <ac:spMk id="9" creationId="{BE6A90BB-2869-46DD-B456-FF04DCEB8C23}"/>
          </ac:spMkLst>
        </pc:spChg>
        <pc:graphicFrameChg chg="modGraphic">
          <ac:chgData name="吉武 和敏" userId="e4825ba96748af9c" providerId="LiveId" clId="{CD5F706F-046B-4764-8521-85C07F58FCCA}" dt="2021-01-25T05:53:51.761" v="67" actId="20577"/>
          <ac:graphicFrameMkLst>
            <pc:docMk/>
            <pc:sldMk cId="1875627820" sldId="777"/>
            <ac:graphicFrameMk id="2" creationId="{978875FE-C22F-4D85-8E8C-D71247B071C5}"/>
          </ac:graphicFrameMkLst>
        </pc:graphicFrameChg>
      </pc:sldChg>
      <pc:sldChg chg="modSp mod">
        <pc:chgData name="吉武 和敏" userId="e4825ba96748af9c" providerId="LiveId" clId="{CD5F706F-046B-4764-8521-85C07F58FCCA}" dt="2021-01-25T05:53:01.003" v="40" actId="20577"/>
        <pc:sldMkLst>
          <pc:docMk/>
          <pc:sldMk cId="2851161679" sldId="781"/>
        </pc:sldMkLst>
        <pc:spChg chg="mod">
          <ac:chgData name="吉武 和敏" userId="e4825ba96748af9c" providerId="LiveId" clId="{CD5F706F-046B-4764-8521-85C07F58FCCA}" dt="2021-01-25T05:53:01.003" v="40" actId="20577"/>
          <ac:spMkLst>
            <pc:docMk/>
            <pc:sldMk cId="2851161679" sldId="781"/>
            <ac:spMk id="9" creationId="{BE6A90BB-2869-46DD-B456-FF04DCEB8C23}"/>
          </ac:spMkLst>
        </pc:spChg>
        <pc:graphicFrameChg chg="modGraphic">
          <ac:chgData name="吉武 和敏" userId="e4825ba96748af9c" providerId="LiveId" clId="{CD5F706F-046B-4764-8521-85C07F58FCCA}" dt="2021-01-25T05:48:58.398" v="11" actId="20577"/>
          <ac:graphicFrameMkLst>
            <pc:docMk/>
            <pc:sldMk cId="2851161679" sldId="781"/>
            <ac:graphicFrameMk id="3" creationId="{8F901316-5907-4C23-866D-867FA4D66F05}"/>
          </ac:graphicFrameMkLst>
        </pc:graphicFrameChg>
      </pc:sldChg>
      <pc:sldChg chg="modSp mod">
        <pc:chgData name="吉武 和敏" userId="e4825ba96748af9c" providerId="LiveId" clId="{CD5F706F-046B-4764-8521-85C07F58FCCA}" dt="2021-01-25T05:47:52.509" v="3" actId="404"/>
        <pc:sldMkLst>
          <pc:docMk/>
          <pc:sldMk cId="487349914" sldId="782"/>
        </pc:sldMkLst>
        <pc:spChg chg="mod">
          <ac:chgData name="吉武 和敏" userId="e4825ba96748af9c" providerId="LiveId" clId="{CD5F706F-046B-4764-8521-85C07F58FCCA}" dt="2021-01-25T05:47:52.509" v="3" actId="404"/>
          <ac:spMkLst>
            <pc:docMk/>
            <pc:sldMk cId="487349914" sldId="782"/>
            <ac:spMk id="3" creationId="{A0336B9C-4DD8-4FF4-88DB-FA6BAC54757E}"/>
          </ac:spMkLst>
        </pc:spChg>
      </pc:sldChg>
    </pc:docChg>
  </pc:docChgLst>
  <pc:docChgLst>
    <pc:chgData name="吉武 和敏" userId="e4825ba96748af9c" providerId="LiveId" clId="{21C562FD-3597-624D-9318-F5CF01B505E0}"/>
    <pc:docChg chg="custSel">
      <pc:chgData name="吉武 和敏" userId="e4825ba96748af9c" providerId="LiveId" clId="{21C562FD-3597-624D-9318-F5CF01B505E0}" dt="2021-05-17T16:04:39.096" v="3" actId="1592"/>
      <pc:docMkLst>
        <pc:docMk/>
      </pc:docMkLst>
      <pc:sldChg chg="delCm">
        <pc:chgData name="吉武 和敏" userId="e4825ba96748af9c" providerId="LiveId" clId="{21C562FD-3597-624D-9318-F5CF01B505E0}" dt="2021-05-17T16:04:39.096" v="2" actId="1592"/>
        <pc:sldMkLst>
          <pc:docMk/>
          <pc:sldMk cId="4253877532" sldId="270"/>
        </pc:sldMkLst>
      </pc:sldChg>
      <pc:sldChg chg="delCm">
        <pc:chgData name="吉武 和敏" userId="e4825ba96748af9c" providerId="LiveId" clId="{21C562FD-3597-624D-9318-F5CF01B505E0}" dt="2021-05-17T16:04:39.096" v="1" actId="1592"/>
        <pc:sldMkLst>
          <pc:docMk/>
          <pc:sldMk cId="2851161679" sldId="781"/>
        </pc:sldMkLst>
      </pc:sldChg>
      <pc:sldChg chg="delCm">
        <pc:chgData name="吉武 和敏" userId="e4825ba96748af9c" providerId="LiveId" clId="{21C562FD-3597-624D-9318-F5CF01B505E0}" dt="2021-05-17T16:04:39.096" v="3" actId="1592"/>
        <pc:sldMkLst>
          <pc:docMk/>
          <pc:sldMk cId="1725616932" sldId="784"/>
        </pc:sldMkLst>
      </pc:sldChg>
    </pc:docChg>
  </pc:docChgLst>
  <pc:docChgLst>
    <pc:chgData name="吉武 和敏" userId="e4825ba96748af9c" providerId="LiveId" clId="{1D11E9A2-FE5F-4347-8903-65500C034D05}"/>
    <pc:docChg chg="modSld">
      <pc:chgData name="吉武 和敏" userId="e4825ba96748af9c" providerId="LiveId" clId="{1D11E9A2-FE5F-4347-8903-65500C034D05}" dt="2021-04-02T08:21:36.116" v="61" actId="13926"/>
      <pc:docMkLst>
        <pc:docMk/>
      </pc:docMkLst>
      <pc:sldChg chg="modSp mod">
        <pc:chgData name="吉武 和敏" userId="e4825ba96748af9c" providerId="LiveId" clId="{1D11E9A2-FE5F-4347-8903-65500C034D05}" dt="2021-04-02T08:21:36.116" v="61" actId="13926"/>
        <pc:sldMkLst>
          <pc:docMk/>
          <pc:sldMk cId="4253877532" sldId="270"/>
        </pc:sldMkLst>
        <pc:graphicFrameChg chg="mod modGraphic">
          <ac:chgData name="吉武 和敏" userId="e4825ba96748af9c" providerId="LiveId" clId="{1D11E9A2-FE5F-4347-8903-65500C034D05}" dt="2021-04-02T08:21:36.116" v="61" actId="13926"/>
          <ac:graphicFrameMkLst>
            <pc:docMk/>
            <pc:sldMk cId="4253877532" sldId="270"/>
            <ac:graphicFrameMk id="2" creationId="{FF9B6FE1-802B-403B-9507-E201D108CDA6}"/>
          </ac:graphicFrameMkLst>
        </pc:graphicFrameChg>
      </pc:sldChg>
      <pc:sldChg chg="modSp mod modCm">
        <pc:chgData name="吉武 和敏" userId="e4825ba96748af9c" providerId="LiveId" clId="{1D11E9A2-FE5F-4347-8903-65500C034D05}" dt="2021-04-02T08:21:30.005" v="60" actId="13926"/>
        <pc:sldMkLst>
          <pc:docMk/>
          <pc:sldMk cId="2851161679" sldId="781"/>
        </pc:sldMkLst>
        <pc:spChg chg="mod">
          <ac:chgData name="吉武 和敏" userId="e4825ba96748af9c" providerId="LiveId" clId="{1D11E9A2-FE5F-4347-8903-65500C034D05}" dt="2021-04-02T08:21:08.530" v="51" actId="13926"/>
          <ac:spMkLst>
            <pc:docMk/>
            <pc:sldMk cId="2851161679" sldId="781"/>
            <ac:spMk id="9" creationId="{BE6A90BB-2869-46DD-B456-FF04DCEB8C23}"/>
          </ac:spMkLst>
        </pc:spChg>
        <pc:graphicFrameChg chg="modGraphic">
          <ac:chgData name="吉武 和敏" userId="e4825ba96748af9c" providerId="LiveId" clId="{1D11E9A2-FE5F-4347-8903-65500C034D05}" dt="2021-04-02T08:21:30.005" v="60" actId="13926"/>
          <ac:graphicFrameMkLst>
            <pc:docMk/>
            <pc:sldMk cId="2851161679" sldId="781"/>
            <ac:graphicFrameMk id="3" creationId="{8F901316-5907-4C23-866D-867FA4D66F05}"/>
          </ac:graphicFrameMkLst>
        </pc:graphicFrameChg>
      </pc:sldChg>
    </pc:docChg>
  </pc:docChgLst>
  <pc:docChgLst>
    <pc:chgData name="吉武 和敏" userId="e4825ba96748af9c" providerId="LiveId" clId="{81509755-935F-4DAD-9BB0-C46535D5F958}"/>
    <pc:docChg chg="modSld">
      <pc:chgData name="吉武 和敏" userId="e4825ba96748af9c" providerId="LiveId" clId="{81509755-935F-4DAD-9BB0-C46535D5F958}" dt="2021-04-19T03:20:16.233" v="27" actId="20577"/>
      <pc:docMkLst>
        <pc:docMk/>
      </pc:docMkLst>
      <pc:sldChg chg="modSp mod">
        <pc:chgData name="吉武 和敏" userId="e4825ba96748af9c" providerId="LiveId" clId="{81509755-935F-4DAD-9BB0-C46535D5F958}" dt="2021-04-19T03:20:16.233" v="27" actId="20577"/>
        <pc:sldMkLst>
          <pc:docMk/>
          <pc:sldMk cId="487349914" sldId="782"/>
        </pc:sldMkLst>
        <pc:spChg chg="mod">
          <ac:chgData name="吉武 和敏" userId="e4825ba96748af9c" providerId="LiveId" clId="{81509755-935F-4DAD-9BB0-C46535D5F958}" dt="2021-04-19T03:20:16.233" v="27" actId="20577"/>
          <ac:spMkLst>
            <pc:docMk/>
            <pc:sldMk cId="487349914" sldId="782"/>
            <ac:spMk id="3" creationId="{A0336B9C-4DD8-4FF4-88DB-FA6BAC54757E}"/>
          </ac:spMkLst>
        </pc:spChg>
      </pc:sldChg>
    </pc:docChg>
  </pc:docChgLst>
  <pc:docChgLst>
    <pc:chgData name="吉武 和敏" userId="e4825ba96748af9c" providerId="LiveId" clId="{4C9C097B-BB55-415C-9869-B19934D7A841}"/>
    <pc:docChg chg="custSel addSld modSld">
      <pc:chgData name="吉武 和敏" userId="e4825ba96748af9c" providerId="LiveId" clId="{4C9C097B-BB55-415C-9869-B19934D7A841}" dt="2021-04-09T15:57:07.855" v="101" actId="20577"/>
      <pc:docMkLst>
        <pc:docMk/>
      </pc:docMkLst>
      <pc:sldChg chg="addSp delSp modSp new mod">
        <pc:chgData name="吉武 和敏" userId="e4825ba96748af9c" providerId="LiveId" clId="{4C9C097B-BB55-415C-9869-B19934D7A841}" dt="2021-04-09T15:57:07.855" v="101" actId="20577"/>
        <pc:sldMkLst>
          <pc:docMk/>
          <pc:sldMk cId="1725616932" sldId="784"/>
        </pc:sldMkLst>
        <pc:spChg chg="add del mod">
          <ac:chgData name="吉武 和敏" userId="e4825ba96748af9c" providerId="LiveId" clId="{4C9C097B-BB55-415C-9869-B19934D7A841}" dt="2021-04-09T03:15:50.041" v="3" actId="478"/>
          <ac:spMkLst>
            <pc:docMk/>
            <pc:sldMk cId="1725616932" sldId="784"/>
            <ac:spMk id="3" creationId="{414F20AF-76EE-4B0F-A9B3-CB4692ED7755}"/>
          </ac:spMkLst>
        </pc:spChg>
        <pc:spChg chg="add mod">
          <ac:chgData name="吉武 和敏" userId="e4825ba96748af9c" providerId="LiveId" clId="{4C9C097B-BB55-415C-9869-B19934D7A841}" dt="2021-04-09T15:57:07.855" v="101" actId="20577"/>
          <ac:spMkLst>
            <pc:docMk/>
            <pc:sldMk cId="1725616932" sldId="784"/>
            <ac:spMk id="4" creationId="{8057AF89-4446-4FCA-8A0A-BC03B5D13741}"/>
          </ac:spMkLst>
        </pc:spChg>
        <pc:picChg chg="add mod">
          <ac:chgData name="吉武 和敏" userId="e4825ba96748af9c" providerId="LiveId" clId="{4C9C097B-BB55-415C-9869-B19934D7A841}" dt="2021-04-09T03:15:53.584" v="5" actId="1076"/>
          <ac:picMkLst>
            <pc:docMk/>
            <pc:sldMk cId="1725616932" sldId="784"/>
            <ac:picMk id="2" creationId="{FF425E50-1677-4E83-9DAC-B73633DFC046}"/>
          </ac:picMkLst>
        </pc:picChg>
      </pc:sldChg>
    </pc:docChg>
  </pc:docChgLst>
  <pc:docChgLst>
    <pc:chgData name="吉武 和敏" userId="e4825ba96748af9c" providerId="LiveId" clId="{E4405E55-8E7E-B14C-878C-36A86FCD2069}"/>
    <pc:docChg chg="custSel addSld modSld">
      <pc:chgData name="吉武 和敏" userId="e4825ba96748af9c" providerId="LiveId" clId="{E4405E55-8E7E-B14C-878C-36A86FCD2069}" dt="2021-02-23T08:58:21.926" v="59" actId="478"/>
      <pc:docMkLst>
        <pc:docMk/>
      </pc:docMkLst>
      <pc:sldChg chg="addSp delSp modSp add mod">
        <pc:chgData name="吉武 和敏" userId="e4825ba96748af9c" providerId="LiveId" clId="{E4405E55-8E7E-B14C-878C-36A86FCD2069}" dt="2021-02-23T08:58:21.926" v="59" actId="478"/>
        <pc:sldMkLst>
          <pc:docMk/>
          <pc:sldMk cId="86459901" sldId="783"/>
        </pc:sldMkLst>
        <pc:spChg chg="add del mod">
          <ac:chgData name="吉武 和敏" userId="e4825ba96748af9c" providerId="LiveId" clId="{E4405E55-8E7E-B14C-878C-36A86FCD2069}" dt="2021-02-23T08:53:55.420" v="21"/>
          <ac:spMkLst>
            <pc:docMk/>
            <pc:sldMk cId="86459901" sldId="783"/>
            <ac:spMk id="2" creationId="{19B9BD0E-10AA-0943-9B5E-0F4153B02E92}"/>
          </ac:spMkLst>
        </pc:spChg>
        <pc:spChg chg="mod">
          <ac:chgData name="吉武 和敏" userId="e4825ba96748af9c" providerId="LiveId" clId="{E4405E55-8E7E-B14C-878C-36A86FCD2069}" dt="2021-02-23T08:57:57.009" v="58" actId="20577"/>
          <ac:spMkLst>
            <pc:docMk/>
            <pc:sldMk cId="86459901" sldId="783"/>
            <ac:spMk id="8" creationId="{00000000-0000-0000-0000-000000000000}"/>
          </ac:spMkLst>
        </pc:spChg>
        <pc:spChg chg="del">
          <ac:chgData name="吉武 和敏" userId="e4825ba96748af9c" providerId="LiveId" clId="{E4405E55-8E7E-B14C-878C-36A86FCD2069}" dt="2021-02-23T08:58:21.926" v="59" actId="478"/>
          <ac:spMkLst>
            <pc:docMk/>
            <pc:sldMk cId="86459901" sldId="783"/>
            <ac:spMk id="9" creationId="{00000000-0000-0000-0000-000000000000}"/>
          </ac:spMkLst>
        </pc:spChg>
        <pc:spChg chg="del">
          <ac:chgData name="吉武 和敏" userId="e4825ba96748af9c" providerId="LiveId" clId="{E4405E55-8E7E-B14C-878C-36A86FCD2069}" dt="2021-02-23T08:53:46.980" v="16" actId="478"/>
          <ac:spMkLst>
            <pc:docMk/>
            <pc:sldMk cId="86459901" sldId="783"/>
            <ac:spMk id="10" creationId="{00000000-0000-0000-0000-000000000000}"/>
          </ac:spMkLst>
        </pc:spChg>
        <pc:spChg chg="add del mod">
          <ac:chgData name="吉武 和敏" userId="e4825ba96748af9c" providerId="LiveId" clId="{E4405E55-8E7E-B14C-878C-36A86FCD2069}" dt="2021-02-23T08:54:21.843" v="28"/>
          <ac:spMkLst>
            <pc:docMk/>
            <pc:sldMk cId="86459901" sldId="783"/>
            <ac:spMk id="12" creationId="{ADB0AE83-75E6-8C47-99CC-FC7FE084BBEC}"/>
          </ac:spMkLst>
        </pc:spChg>
        <pc:spChg chg="del">
          <ac:chgData name="吉武 和敏" userId="e4825ba96748af9c" providerId="LiveId" clId="{E4405E55-8E7E-B14C-878C-36A86FCD2069}" dt="2021-02-23T08:53:39.849" v="14" actId="478"/>
          <ac:spMkLst>
            <pc:docMk/>
            <pc:sldMk cId="86459901" sldId="783"/>
            <ac:spMk id="15" creationId="{00000000-0000-0000-0000-000000000000}"/>
          </ac:spMkLst>
        </pc:spChg>
        <pc:spChg chg="del">
          <ac:chgData name="吉武 和敏" userId="e4825ba96748af9c" providerId="LiveId" clId="{E4405E55-8E7E-B14C-878C-36A86FCD2069}" dt="2021-02-23T08:53:43.059" v="15" actId="478"/>
          <ac:spMkLst>
            <pc:docMk/>
            <pc:sldMk cId="86459901" sldId="783"/>
            <ac:spMk id="17" creationId="{00000000-0000-0000-0000-000000000000}"/>
          </ac:spMkLst>
        </pc:spChg>
        <pc:spChg chg="del">
          <ac:chgData name="吉武 和敏" userId="e4825ba96748af9c" providerId="LiveId" clId="{E4405E55-8E7E-B14C-878C-36A86FCD2069}" dt="2021-02-23T08:53:48.113" v="17" actId="478"/>
          <ac:spMkLst>
            <pc:docMk/>
            <pc:sldMk cId="86459901" sldId="783"/>
            <ac:spMk id="19" creationId="{00000000-0000-0000-0000-000000000000}"/>
          </ac:spMkLst>
        </pc:spChg>
        <pc:spChg chg="del">
          <ac:chgData name="吉武 和敏" userId="e4825ba96748af9c" providerId="LiveId" clId="{E4405E55-8E7E-B14C-878C-36A86FCD2069}" dt="2021-02-23T08:53:38.146" v="13" actId="478"/>
          <ac:spMkLst>
            <pc:docMk/>
            <pc:sldMk cId="86459901" sldId="783"/>
            <ac:spMk id="22" creationId="{00000000-0000-0000-0000-000000000000}"/>
          </ac:spMkLst>
        </pc:spChg>
        <pc:spChg chg="add mod">
          <ac:chgData name="吉武 和敏" userId="e4825ba96748af9c" providerId="LiveId" clId="{E4405E55-8E7E-B14C-878C-36A86FCD2069}" dt="2021-02-23T08:56:50.937" v="32" actId="164"/>
          <ac:spMkLst>
            <pc:docMk/>
            <pc:sldMk cId="86459901" sldId="783"/>
            <ac:spMk id="23" creationId="{0C531D37-3EBF-3A4B-BC02-A024016603E1}"/>
          </ac:spMkLst>
        </pc:spChg>
        <pc:spChg chg="add mod">
          <ac:chgData name="吉武 和敏" userId="e4825ba96748af9c" providerId="LiveId" clId="{E4405E55-8E7E-B14C-878C-36A86FCD2069}" dt="2021-02-23T08:56:50.937" v="32" actId="164"/>
          <ac:spMkLst>
            <pc:docMk/>
            <pc:sldMk cId="86459901" sldId="783"/>
            <ac:spMk id="24" creationId="{9A00FB17-F582-F04E-A8AB-BEFFDB7F7FCE}"/>
          </ac:spMkLst>
        </pc:spChg>
        <pc:spChg chg="add mod">
          <ac:chgData name="吉武 和敏" userId="e4825ba96748af9c" providerId="LiveId" clId="{E4405E55-8E7E-B14C-878C-36A86FCD2069}" dt="2021-02-23T08:56:50.937" v="32" actId="164"/>
          <ac:spMkLst>
            <pc:docMk/>
            <pc:sldMk cId="86459901" sldId="783"/>
            <ac:spMk id="25" creationId="{9C198721-4F2C-6F46-9F42-777B9C8854B6}"/>
          </ac:spMkLst>
        </pc:spChg>
        <pc:spChg chg="add mod">
          <ac:chgData name="吉武 和敏" userId="e4825ba96748af9c" providerId="LiveId" clId="{E4405E55-8E7E-B14C-878C-36A86FCD2069}" dt="2021-02-23T08:56:50.937" v="32" actId="164"/>
          <ac:spMkLst>
            <pc:docMk/>
            <pc:sldMk cId="86459901" sldId="783"/>
            <ac:spMk id="26" creationId="{31915524-EE9D-6A47-93F2-2DACD70CC621}"/>
          </ac:spMkLst>
        </pc:spChg>
        <pc:spChg chg="add mod">
          <ac:chgData name="吉武 和敏" userId="e4825ba96748af9c" providerId="LiveId" clId="{E4405E55-8E7E-B14C-878C-36A86FCD2069}" dt="2021-02-23T08:56:50.937" v="32" actId="164"/>
          <ac:spMkLst>
            <pc:docMk/>
            <pc:sldMk cId="86459901" sldId="783"/>
            <ac:spMk id="27" creationId="{8E04DA60-BA03-FB42-9E2E-A9197D19A6C4}"/>
          </ac:spMkLst>
        </pc:spChg>
        <pc:spChg chg="add mod">
          <ac:chgData name="吉武 和敏" userId="e4825ba96748af9c" providerId="LiveId" clId="{E4405E55-8E7E-B14C-878C-36A86FCD2069}" dt="2021-02-23T08:56:50.937" v="32" actId="164"/>
          <ac:spMkLst>
            <pc:docMk/>
            <pc:sldMk cId="86459901" sldId="783"/>
            <ac:spMk id="28" creationId="{29422DAB-C9FF-984F-9DC8-861D2510A404}"/>
          </ac:spMkLst>
        </pc:spChg>
        <pc:spChg chg="add mod">
          <ac:chgData name="吉武 和敏" userId="e4825ba96748af9c" providerId="LiveId" clId="{E4405E55-8E7E-B14C-878C-36A86FCD2069}" dt="2021-02-23T08:56:50.937" v="32" actId="164"/>
          <ac:spMkLst>
            <pc:docMk/>
            <pc:sldMk cId="86459901" sldId="783"/>
            <ac:spMk id="29" creationId="{7844DC67-E820-9B4A-A1C6-7D6D4429D851}"/>
          </ac:spMkLst>
        </pc:spChg>
        <pc:spChg chg="add mod">
          <ac:chgData name="吉武 和敏" userId="e4825ba96748af9c" providerId="LiveId" clId="{E4405E55-8E7E-B14C-878C-36A86FCD2069}" dt="2021-02-23T08:56:50.937" v="32" actId="164"/>
          <ac:spMkLst>
            <pc:docMk/>
            <pc:sldMk cId="86459901" sldId="783"/>
            <ac:spMk id="30" creationId="{40C3B60C-950A-5C41-8ACB-1424842EC9A3}"/>
          </ac:spMkLst>
        </pc:spChg>
        <pc:grpChg chg="del">
          <ac:chgData name="吉武 和敏" userId="e4825ba96748af9c" providerId="LiveId" clId="{E4405E55-8E7E-B14C-878C-36A86FCD2069}" dt="2021-02-23T08:53:36.309" v="12" actId="478"/>
          <ac:grpSpMkLst>
            <pc:docMk/>
            <pc:sldMk cId="86459901" sldId="783"/>
            <ac:grpSpMk id="7" creationId="{00000000-0000-0000-0000-000000000000}"/>
          </ac:grpSpMkLst>
        </pc:grpChg>
        <pc:grpChg chg="add mod">
          <ac:chgData name="吉武 和敏" userId="e4825ba96748af9c" providerId="LiveId" clId="{E4405E55-8E7E-B14C-878C-36A86FCD2069}" dt="2021-02-23T08:57:19.333" v="37" actId="1076"/>
          <ac:grpSpMkLst>
            <pc:docMk/>
            <pc:sldMk cId="86459901" sldId="783"/>
            <ac:grpSpMk id="14" creationId="{D4C6FFAE-3541-ED48-BC32-13E9D2104A74}"/>
          </ac:grpSpMkLst>
        </pc:grpChg>
        <pc:grpChg chg="del">
          <ac:chgData name="吉武 和敏" userId="e4825ba96748af9c" providerId="LiveId" clId="{E4405E55-8E7E-B14C-878C-36A86FCD2069}" dt="2021-02-23T08:53:29.306" v="8" actId="478"/>
          <ac:grpSpMkLst>
            <pc:docMk/>
            <pc:sldMk cId="86459901" sldId="783"/>
            <ac:grpSpMk id="21" creationId="{00000000-0000-0000-0000-000000000000}"/>
          </ac:grpSpMkLst>
        </pc:grpChg>
        <pc:graphicFrameChg chg="del mod">
          <ac:chgData name="吉武 和敏" userId="e4825ba96748af9c" providerId="LiveId" clId="{E4405E55-8E7E-B14C-878C-36A86FCD2069}" dt="2021-02-23T08:53:34.768" v="11" actId="478"/>
          <ac:graphicFrameMkLst>
            <pc:docMk/>
            <pc:sldMk cId="86459901" sldId="783"/>
            <ac:graphicFrameMk id="3" creationId="{513D3A4F-FE27-4D67-B6E1-D1CEE87A0658}"/>
          </ac:graphicFrameMkLst>
        </pc:graphicFrameChg>
        <pc:graphicFrameChg chg="del">
          <ac:chgData name="吉武 和敏" userId="e4825ba96748af9c" providerId="LiveId" clId="{E4405E55-8E7E-B14C-878C-36A86FCD2069}" dt="2021-02-23T08:53:30.234" v="9" actId="478"/>
          <ac:graphicFrameMkLst>
            <pc:docMk/>
            <pc:sldMk cId="86459901" sldId="783"/>
            <ac:graphicFrameMk id="4" creationId="{DE7F0418-15D8-433C-BD25-6C6421A0B8A8}"/>
          </ac:graphicFrameMkLst>
        </pc:graphicFrameChg>
        <pc:picChg chg="add mod modCrop">
          <ac:chgData name="吉武 和敏" userId="e4825ba96748af9c" providerId="LiveId" clId="{E4405E55-8E7E-B14C-878C-36A86FCD2069}" dt="2021-02-23T08:53:12.132" v="7" actId="732"/>
          <ac:picMkLst>
            <pc:docMk/>
            <pc:sldMk cId="86459901" sldId="783"/>
            <ac:picMk id="11" creationId="{9CF27DCA-4DE0-654F-8D7F-28F103DF1FC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8419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3787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6505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365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9292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4829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6748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67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4068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170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4709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0459E-C103-4843-848A-4D15ECB21ED5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386183-BA2B-40F7-916B-2B5A173E6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565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0336B9C-4DD8-4FF4-88DB-FA6BAC54757E}"/>
              </a:ext>
            </a:extLst>
          </p:cNvPr>
          <p:cNvSpPr txBox="1"/>
          <p:nvPr/>
        </p:nvSpPr>
        <p:spPr>
          <a:xfrm>
            <a:off x="0" y="0"/>
            <a:ext cx="9144000" cy="62986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velopment of a time-series shotgun metagenomics database for monitoring microbial communities at the Pacific coast of Japan</a:t>
            </a:r>
            <a:endParaRPr lang="ja-JP" altLang="ja-JP" sz="18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>
              <a:lnSpc>
                <a:spcPct val="116000"/>
              </a:lnSpc>
            </a:pPr>
            <a:r>
              <a:rPr lang="en-US" altLang="ja-JP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 </a:t>
            </a:r>
            <a:endParaRPr lang="ja-JP" altLang="ja-JP" sz="14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pPr algn="just"/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Kazutoshi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Yoshitake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,2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Gaku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Kimura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2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Tomoko Sakam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3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Tsuyoshi Watanabe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3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Yukiko Taniuch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3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Shigeh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Kakeh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3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Akira Kuwata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3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Haruy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Yamaguch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4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Takafumi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Kataoka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5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Masanobu Kawach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4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Kazuh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Ikeo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6,7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Engkong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Tan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Yoji Igarash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Masafumi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Ohtsubo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8</a:t>
            </a:r>
            <a:r>
              <a:rPr lang="en-US" altLang="ja-JP" sz="1400" dirty="0">
                <a:effectLst/>
                <a:latin typeface="ＭＳ 明朝" panose="02020609040205080304" pitchFamily="17" charset="-128"/>
                <a:ea typeface="游明朝" panose="02020400000000000000" pitchFamily="18" charset="-128"/>
                <a:cs typeface="ＭＳ 明朝" panose="02020609040205080304" pitchFamily="17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Shug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Watabe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9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Yutaka Suzuk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0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Shuichi Asakawa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Sonok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Ishino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1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Kosuke Tashiro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1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Yoshizumi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Ishino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1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Takanori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Kobayash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3,9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, Katsuhiko Mineta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2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and Takashi Gojobori</a:t>
            </a:r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12</a:t>
            </a:r>
            <a:endParaRPr lang="ja-JP" altLang="ja-JP" sz="14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pPr algn="just">
              <a:lnSpc>
                <a:spcPct val="91000"/>
              </a:lnSpc>
            </a:pP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 </a:t>
            </a:r>
            <a:endParaRPr lang="ja-JP" altLang="ja-JP" sz="14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pPr algn="just"/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Corresponding author: Takashi </a:t>
            </a:r>
            <a:r>
              <a:rPr lang="en-US" altLang="ja-JP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Gojobori</a:t>
            </a:r>
            <a:endParaRPr lang="ja-JP" altLang="ja-JP" sz="14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pPr algn="just"/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E-mail: takashi.gojobori@kaust.edu.sa</a:t>
            </a:r>
            <a:endParaRPr lang="ja-JP" altLang="ja-JP" sz="14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pPr algn="just"/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 </a:t>
            </a:r>
            <a:endParaRPr lang="ja-JP" altLang="ja-JP" sz="14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boratory of Aquatic Molecular Biology and Biotechnology, Graduate School of Agricultural and Life Sciences, The University of Tokyo, Yayoi, Bunkyo, Tokyo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apan Software Management Co., Ltd., Kinko-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Yokohama, Kanagawa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apan Fisheries Research and Education Agency, Minato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ai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Nishi-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u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Yokohama, Kanagawa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er for Environmental Biology and Ecosystem Studies, National Institute for Environmental Studies, 16-2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ogawa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Tsukuba, Ibaraki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culty of Marine Science and Technology, Fukui Prefectural University, 1-1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kuen-ch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Obama, Fukui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Genetics, SOKENDAI, Mishima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tional Institute of Genetics, Mishima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eminent Medical Photonics Education &amp; Research Center, Hamamatsu University School of Medicine, 1-20-1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ndayama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igashi-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u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amamatsu, Shizuoka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Marine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iosciences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tasat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iversity, Sagamihara, Kanagawa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Computational Biology and Medical Sciences, Graduate School of Frontier Sciences, The University of Tokyo, 5-1-5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shiwanoha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ashiwa, Chiba, 277-8561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1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science and Biotechnology, Graduate School of Bioresource and Bioenvironmental Sciences, Kyushu University, Fukuoka, Japan</a:t>
            </a:r>
            <a:endParaRPr lang="ja-JP" altLang="ja-JP" sz="14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2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King Abdullah University of Science and Technology, Computational Bioscience Research Center, </a:t>
            </a:r>
            <a:r>
              <a:rPr lang="en-US" altLang="ja-JP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uwal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Saudi Arabia</a:t>
            </a:r>
            <a:endParaRPr lang="ja-JP" altLang="ja-JP" sz="1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87349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E6A90BB-2869-46DD-B456-FF04DCEB8C23}"/>
              </a:ext>
            </a:extLst>
          </p:cNvPr>
          <p:cNvSpPr txBox="1"/>
          <p:nvPr/>
        </p:nvSpPr>
        <p:spPr>
          <a:xfrm>
            <a:off x="109056" y="1571109"/>
            <a:ext cx="68115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Supplementary Information 1.   Number of sequenced samples for each filter size</a:t>
            </a:r>
          </a:p>
          <a:p>
            <a:endParaRPr kumimoji="1" lang="ja-JP" altLang="en-US" sz="1400" dirty="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8F901316-5907-4C23-866D-867FA4D66F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0538048"/>
              </p:ext>
            </p:extLst>
          </p:nvPr>
        </p:nvGraphicFramePr>
        <p:xfrm>
          <a:off x="2546839" y="2204982"/>
          <a:ext cx="3181608" cy="2017395"/>
        </p:xfrm>
        <a:graphic>
          <a:graphicData uri="http://schemas.openxmlformats.org/drawingml/2006/table">
            <a:tbl>
              <a:tblPr firstRow="1" lastRow="1">
                <a:tableStyleId>{9D7B26C5-4107-4FEC-AEDC-1716B250A1EF}</a:tableStyleId>
              </a:tblPr>
              <a:tblGrid>
                <a:gridCol w="1590804">
                  <a:extLst>
                    <a:ext uri="{9D8B030D-6E8A-4147-A177-3AD203B41FA5}">
                      <a16:colId xmlns:a16="http://schemas.microsoft.com/office/drawing/2014/main" val="566569573"/>
                    </a:ext>
                  </a:extLst>
                </a:gridCol>
                <a:gridCol w="1590804">
                  <a:extLst>
                    <a:ext uri="{9D8B030D-6E8A-4147-A177-3AD203B41FA5}">
                      <a16:colId xmlns:a16="http://schemas.microsoft.com/office/drawing/2014/main" val="2187913222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u="none" strike="noStrike" dirty="0">
                          <a:effectLst/>
                        </a:rPr>
                        <a:t>Filter size [µm]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u="none" strike="noStrike" dirty="0">
                          <a:effectLst/>
                        </a:rPr>
                        <a:t>Number of sample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62793665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0.2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127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91353257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0.8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117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52710022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5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90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0554135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20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107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34363681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100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>
                          <a:effectLst/>
                        </a:rPr>
                        <a:t>13</a:t>
                      </a:r>
                      <a:endParaRPr lang="en-US" altLang="ja-JP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493164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u="none" strike="noStrike" dirty="0">
                          <a:effectLst/>
                        </a:rPr>
                        <a:t>Total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600" u="none" strike="noStrike" dirty="0">
                          <a:effectLst/>
                        </a:rPr>
                        <a:t>454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63898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511616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FF9B6FE1-802B-403B-9507-E201D108CD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8511932"/>
              </p:ext>
            </p:extLst>
          </p:nvPr>
        </p:nvGraphicFramePr>
        <p:xfrm>
          <a:off x="1523999" y="1397000"/>
          <a:ext cx="7194486" cy="23723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42654">
                  <a:extLst>
                    <a:ext uri="{9D8B030D-6E8A-4147-A177-3AD203B41FA5}">
                      <a16:colId xmlns:a16="http://schemas.microsoft.com/office/drawing/2014/main" val="602610756"/>
                    </a:ext>
                  </a:extLst>
                </a:gridCol>
                <a:gridCol w="1557197">
                  <a:extLst>
                    <a:ext uri="{9D8B030D-6E8A-4147-A177-3AD203B41FA5}">
                      <a16:colId xmlns:a16="http://schemas.microsoft.com/office/drawing/2014/main" val="1645017795"/>
                    </a:ext>
                  </a:extLst>
                </a:gridCol>
                <a:gridCol w="1647730">
                  <a:extLst>
                    <a:ext uri="{9D8B030D-6E8A-4147-A177-3AD203B41FA5}">
                      <a16:colId xmlns:a16="http://schemas.microsoft.com/office/drawing/2014/main" val="2032945038"/>
                    </a:ext>
                  </a:extLst>
                </a:gridCol>
                <a:gridCol w="1846905">
                  <a:extLst>
                    <a:ext uri="{9D8B030D-6E8A-4147-A177-3AD203B41FA5}">
                      <a16:colId xmlns:a16="http://schemas.microsoft.com/office/drawing/2014/main" val="39178177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/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otgun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S rRNA gene amplic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S rRNA gene amplic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49742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d samples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4 samples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 samples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 samples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57657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erage sequenced read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87 × 10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ead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24 ×</a:t>
                      </a:r>
                      <a:r>
                        <a:rPr lang="en-US" sz="1400" spc="1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10</a:t>
                      </a:r>
                      <a:r>
                        <a:rPr lang="en-US" sz="1400" spc="15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ead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1 ×</a:t>
                      </a:r>
                      <a:r>
                        <a:rPr lang="en-US" sz="1400" spc="1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10</a:t>
                      </a:r>
                      <a:r>
                        <a:rPr lang="en-US" sz="1400" spc="15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ead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5773549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erage sequenced bases</a:t>
                      </a:r>
                      <a:endParaRPr lang="ja-JP" sz="12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85 × 10</a:t>
                      </a:r>
                      <a:r>
                        <a:rPr lang="en-US" sz="14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ases</a:t>
                      </a:r>
                      <a:endParaRPr lang="ja-JP" sz="12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52 × 10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ase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45 × 10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ase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12433745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al sequenced reads</a:t>
                      </a:r>
                      <a:endParaRPr lang="ja-JP" sz="12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57 × 10</a:t>
                      </a:r>
                      <a:r>
                        <a:rPr lang="en-US" sz="14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eads</a:t>
                      </a:r>
                      <a:endParaRPr lang="ja-JP" sz="12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92 × 10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ead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57 × 10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ead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4460398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al sequenced bases</a:t>
                      </a:r>
                      <a:endParaRPr lang="ja-JP" sz="12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56 × 10</a:t>
                      </a:r>
                      <a:r>
                        <a:rPr lang="en-US" sz="14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ases</a:t>
                      </a:r>
                      <a:endParaRPr lang="ja-JP" sz="120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69 × 10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ase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10 × 10</a:t>
                      </a:r>
                      <a:r>
                        <a:rPr lang="en-US" sz="14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ases</a:t>
                      </a:r>
                      <a:endParaRPr lang="ja-JP" sz="1200" dirty="0">
                        <a:effectLst/>
                        <a:latin typeface="Calibri" panose="020F0502020204030204" pitchFamily="34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00" marR="25400" marT="0" marB="0"/>
                </a:tc>
                <a:extLst>
                  <a:ext uri="{0D108BD9-81ED-4DB2-BD59-A6C34878D82A}">
                    <a16:rowId xmlns:a16="http://schemas.microsoft.com/office/drawing/2014/main" val="488487572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E6A90BB-2869-46DD-B456-FF04DCEB8C23}"/>
              </a:ext>
            </a:extLst>
          </p:cNvPr>
          <p:cNvSpPr txBox="1"/>
          <p:nvPr/>
        </p:nvSpPr>
        <p:spPr>
          <a:xfrm>
            <a:off x="109057" y="829963"/>
            <a:ext cx="45404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upplementary Information 2.  Summary </a:t>
            </a:r>
            <a:r>
              <a:rPr lang="en-US" altLang="ja-JP" sz="1400" dirty="0"/>
              <a:t>of sequenced data</a:t>
            </a:r>
            <a:endParaRPr kumimoji="1" lang="en-US" altLang="ja-JP" sz="1400" dirty="0"/>
          </a:p>
        </p:txBody>
      </p:sp>
    </p:spTree>
    <p:extLst>
      <p:ext uri="{BB962C8B-B14F-4D97-AF65-F5344CB8AC3E}">
        <p14:creationId xmlns:p14="http://schemas.microsoft.com/office/powerpoint/2010/main" val="42538775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E6A90BB-2869-46DD-B456-FF04DCEB8C23}"/>
              </a:ext>
            </a:extLst>
          </p:cNvPr>
          <p:cNvSpPr txBox="1"/>
          <p:nvPr/>
        </p:nvSpPr>
        <p:spPr>
          <a:xfrm>
            <a:off x="109057" y="1003218"/>
            <a:ext cx="38173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Supplementary Information 3. </a:t>
            </a:r>
            <a:r>
              <a:rPr lang="ja-JP" altLang="en-US" sz="1400" dirty="0"/>
              <a:t> </a:t>
            </a:r>
            <a:r>
              <a:rPr lang="en-US" altLang="ja-JP" sz="1400" dirty="0"/>
              <a:t>Assembled contigs</a:t>
            </a:r>
            <a:endParaRPr kumimoji="1" lang="ja-JP" altLang="en-US" sz="1400" dirty="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F1E5A4E6-A009-421F-BE31-E2D3F1671D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4949902"/>
              </p:ext>
            </p:extLst>
          </p:nvPr>
        </p:nvGraphicFramePr>
        <p:xfrm>
          <a:off x="2041595" y="1511024"/>
          <a:ext cx="5410200" cy="1915160"/>
        </p:xfrm>
        <a:graphic>
          <a:graphicData uri="http://schemas.openxmlformats.org/drawingml/2006/table">
            <a:tbl>
              <a:tblPr firstRow="1">
                <a:tableStyleId>{616DA210-FB5B-4158-B5E0-FEB733F419BA}</a:tableStyleId>
              </a:tblPr>
              <a:tblGrid>
                <a:gridCol w="2705100">
                  <a:extLst>
                    <a:ext uri="{9D8B030D-6E8A-4147-A177-3AD203B41FA5}">
                      <a16:colId xmlns:a16="http://schemas.microsoft.com/office/drawing/2014/main" val="3762535619"/>
                    </a:ext>
                  </a:extLst>
                </a:gridCol>
                <a:gridCol w="2705100">
                  <a:extLst>
                    <a:ext uri="{9D8B030D-6E8A-4147-A177-3AD203B41FA5}">
                      <a16:colId xmlns:a16="http://schemas.microsoft.com/office/drawing/2014/main" val="208876714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 dirty="0">
                          <a:effectLst/>
                        </a:rPr>
                        <a:t>Assembled contigs</a:t>
                      </a:r>
                      <a:endParaRPr lang="en-US" dirty="0">
                        <a:effectLst/>
                      </a:endParaRPr>
                    </a:p>
                  </a:txBody>
                  <a:tcPr marL="63500" marR="63500" marT="63500" marB="635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78060009"/>
                  </a:ext>
                </a:extLst>
              </a:tr>
              <a:tr h="393700">
                <a:tc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>
                          <a:effectLst/>
                        </a:rPr>
                        <a:t>N50</a:t>
                      </a:r>
                      <a:endParaRPr lang="en-US">
                        <a:effectLst/>
                      </a:endParaRPr>
                    </a:p>
                  </a:txBody>
                  <a:tcPr marL="63500" marR="63500" marT="63500" marB="63500"/>
                </a:tc>
                <a:tc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>
                          <a:effectLst/>
                        </a:rPr>
                        <a:t>995 bp</a:t>
                      </a:r>
                      <a:endParaRPr lang="en-US">
                        <a:effectLst/>
                      </a:endParaRPr>
                    </a:p>
                  </a:txBody>
                  <a:tcPr marL="63500" marR="63500" marT="63500" marB="63500"/>
                </a:tc>
                <a:extLst>
                  <a:ext uri="{0D108BD9-81ED-4DB2-BD59-A6C34878D82A}">
                    <a16:rowId xmlns:a16="http://schemas.microsoft.com/office/drawing/2014/main" val="2294343147"/>
                  </a:ext>
                </a:extLst>
              </a:tr>
              <a:tr h="393700">
                <a:tc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 dirty="0">
                          <a:effectLst/>
                        </a:rPr>
                        <a:t>Maximum length</a:t>
                      </a:r>
                      <a:endParaRPr lang="en-US" dirty="0">
                        <a:effectLst/>
                      </a:endParaRPr>
                    </a:p>
                  </a:txBody>
                  <a:tcPr marL="63500" marR="63500" marT="63500" marB="63500"/>
                </a:tc>
                <a:tc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>
                          <a:effectLst/>
                        </a:rPr>
                        <a:t>307,212 bp</a:t>
                      </a:r>
                      <a:endParaRPr lang="en-US">
                        <a:effectLst/>
                      </a:endParaRPr>
                    </a:p>
                  </a:txBody>
                  <a:tcPr marL="63500" marR="63500" marT="63500" marB="63500"/>
                </a:tc>
                <a:extLst>
                  <a:ext uri="{0D108BD9-81ED-4DB2-BD59-A6C34878D82A}">
                    <a16:rowId xmlns:a16="http://schemas.microsoft.com/office/drawing/2014/main" val="1465214352"/>
                  </a:ext>
                </a:extLst>
              </a:tr>
              <a:tr h="393700">
                <a:tc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 dirty="0">
                          <a:effectLst/>
                        </a:rPr>
                        <a:t>Sum</a:t>
                      </a:r>
                      <a:endParaRPr lang="en-US" dirty="0">
                        <a:effectLst/>
                      </a:endParaRPr>
                    </a:p>
                  </a:txBody>
                  <a:tcPr marL="63500" marR="63500" marT="63500" marB="63500"/>
                </a:tc>
                <a:tc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 dirty="0">
                          <a:effectLst/>
                        </a:rPr>
                        <a:t>12.39 </a:t>
                      </a:r>
                      <a:r>
                        <a:rPr lang="en-US" sz="1400" u="none" strike="noStrike" dirty="0" err="1">
                          <a:effectLst/>
                        </a:rPr>
                        <a:t>Gbp</a:t>
                      </a:r>
                      <a:endParaRPr lang="en-US" dirty="0">
                        <a:effectLst/>
                      </a:endParaRPr>
                    </a:p>
                  </a:txBody>
                  <a:tcPr marL="63500" marR="63500" marT="63500" marB="63500"/>
                </a:tc>
                <a:extLst>
                  <a:ext uri="{0D108BD9-81ED-4DB2-BD59-A6C34878D82A}">
                    <a16:rowId xmlns:a16="http://schemas.microsoft.com/office/drawing/2014/main" val="3194462281"/>
                  </a:ext>
                </a:extLst>
              </a:tr>
              <a:tr h="393700">
                <a:tc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 dirty="0">
                          <a:effectLst/>
                        </a:rPr>
                        <a:t>Number of contigs</a:t>
                      </a:r>
                      <a:endParaRPr lang="en-US" dirty="0">
                        <a:effectLst/>
                      </a:endParaRPr>
                    </a:p>
                  </a:txBody>
                  <a:tcPr marL="63500" marR="63500" marT="63500" marB="63500"/>
                </a:tc>
                <a:tc>
                  <a:txBody>
                    <a:bodyPr/>
                    <a:lstStyle/>
                    <a:p>
                      <a:pPr algn="just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u="none" strike="noStrike" dirty="0">
                          <a:effectLst/>
                        </a:rPr>
                        <a:t>57.95 × 10</a:t>
                      </a:r>
                      <a:r>
                        <a:rPr lang="en-US" sz="1400" u="none" strike="noStrike" baseline="30000" dirty="0">
                          <a:effectLst/>
                        </a:rPr>
                        <a:t>6</a:t>
                      </a:r>
                      <a:endParaRPr lang="en-US" baseline="30000" dirty="0">
                        <a:effectLst/>
                      </a:endParaRPr>
                    </a:p>
                  </a:txBody>
                  <a:tcPr marL="63500" marR="63500" marT="63500" marB="63500"/>
                </a:tc>
                <a:extLst>
                  <a:ext uri="{0D108BD9-81ED-4DB2-BD59-A6C34878D82A}">
                    <a16:rowId xmlns:a16="http://schemas.microsoft.com/office/drawing/2014/main" val="20063713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71958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E6A90BB-2869-46DD-B456-FF04DCEB8C23}"/>
              </a:ext>
            </a:extLst>
          </p:cNvPr>
          <p:cNvSpPr txBox="1"/>
          <p:nvPr/>
        </p:nvSpPr>
        <p:spPr>
          <a:xfrm>
            <a:off x="109058" y="1436355"/>
            <a:ext cx="87660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Supplementary Information 4.  Percentage of BLAST and CCP annotations matched to the longest contigs in the top 10,000 clusters of abundance</a:t>
            </a:r>
            <a:endParaRPr kumimoji="1" lang="ja-JP" altLang="en-US" sz="1400" dirty="0"/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978875FE-C22F-4D85-8E8C-D71247B071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4840516"/>
              </p:ext>
            </p:extLst>
          </p:nvPr>
        </p:nvGraphicFramePr>
        <p:xfrm>
          <a:off x="1635417" y="2231549"/>
          <a:ext cx="5399722" cy="2255520"/>
        </p:xfrm>
        <a:graphic>
          <a:graphicData uri="http://schemas.openxmlformats.org/drawingml/2006/table">
            <a:tbl>
              <a:tblPr/>
              <a:tblGrid>
                <a:gridCol w="2699861">
                  <a:extLst>
                    <a:ext uri="{9D8B030D-6E8A-4147-A177-3AD203B41FA5}">
                      <a16:colId xmlns:a16="http://schemas.microsoft.com/office/drawing/2014/main" val="1528453835"/>
                    </a:ext>
                  </a:extLst>
                </a:gridCol>
                <a:gridCol w="2699861">
                  <a:extLst>
                    <a:ext uri="{9D8B030D-6E8A-4147-A177-3AD203B41FA5}">
                      <a16:colId xmlns:a16="http://schemas.microsoft.com/office/drawing/2014/main" val="2647507307"/>
                    </a:ext>
                  </a:extLst>
                </a:gridCol>
              </a:tblGrid>
              <a:tr h="411551">
                <a:tc>
                  <a:txBody>
                    <a:bodyPr/>
                    <a:lstStyle/>
                    <a:p>
                      <a:pPr fontAlgn="t"/>
                      <a:br>
                        <a:rPr lang="ja-JP" altLang="en-US" sz="1400">
                          <a:effectLst/>
                        </a:rPr>
                      </a:br>
                      <a:endParaRPr lang="ja-JP" altLang="en-US" sz="140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Matched percentage</a:t>
                      </a:r>
                      <a:endParaRPr lang="en-US" sz="1400" dirty="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043839"/>
                  </a:ext>
                </a:extLst>
              </a:tr>
              <a:tr h="252972"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ja-JP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V</a:t>
                      </a:r>
                      <a:r>
                        <a:rPr lang="en-US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irus or not</a:t>
                      </a:r>
                      <a:endParaRPr lang="en-US" sz="1400" dirty="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ja-JP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89.6</a:t>
                      </a:r>
                      <a:endParaRPr lang="ja-JP" altLang="en-US" sz="1400" dirty="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9165747"/>
                  </a:ext>
                </a:extLst>
              </a:tr>
              <a:tr h="252972"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Kingdom</a:t>
                      </a:r>
                      <a:endParaRPr lang="en-US" sz="1400" dirty="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ja-JP" sz="1400" b="0" i="0" u="none" strike="noStrike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76.9</a:t>
                      </a:r>
                      <a:endParaRPr lang="ja-JP" altLang="en-US" sz="140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5075831"/>
                  </a:ext>
                </a:extLst>
              </a:tr>
              <a:tr h="252972"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Phylum</a:t>
                      </a:r>
                      <a:endParaRPr lang="en-US" sz="1400" dirty="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ja-JP" sz="1400" b="0" i="0" u="none" strike="noStrike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43.4</a:t>
                      </a:r>
                      <a:endParaRPr lang="ja-JP" altLang="en-US" sz="140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6839996"/>
                  </a:ext>
                </a:extLst>
              </a:tr>
              <a:tr h="252972"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Class</a:t>
                      </a:r>
                      <a:endParaRPr lang="en-US" sz="1400" dirty="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ja-JP" sz="1400" b="0" i="0" u="none" strike="noStrike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17.7</a:t>
                      </a:r>
                      <a:endParaRPr lang="ja-JP" altLang="en-US" sz="140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212760"/>
                  </a:ext>
                </a:extLst>
              </a:tr>
              <a:tr h="252972"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Family</a:t>
                      </a:r>
                      <a:endParaRPr lang="en-US" sz="1400" dirty="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ja-JP" sz="14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</a:rPr>
                        <a:t>1.5</a:t>
                      </a:r>
                      <a:endParaRPr lang="ja-JP" altLang="en-US" sz="1400" dirty="0">
                        <a:effectLst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08200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756278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3800153" y="5855429"/>
            <a:ext cx="526081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Supplementary Information 5.  Percentage of (TAG)n repeats in samples acquired from the Pacific Coast of northeast Japan (</a:t>
            </a:r>
            <a:r>
              <a:rPr lang="en-US" altLang="ja-JP" sz="1400" b="1" dirty="0"/>
              <a:t>a</a:t>
            </a:r>
            <a:r>
              <a:rPr lang="en-US" altLang="ja-JP" sz="1400" dirty="0"/>
              <a:t>) and (</a:t>
            </a:r>
            <a:r>
              <a:rPr lang="en-US" altLang="ja-JP" sz="1400" b="1" dirty="0"/>
              <a:t>b</a:t>
            </a:r>
            <a:r>
              <a:rPr lang="en-US" altLang="ja-JP" sz="1400" dirty="0"/>
              <a:t>). Percentage of (TAG)n </a:t>
            </a:r>
            <a:r>
              <a:rPr lang="en-US" altLang="ja-JP" sz="1400" dirty="0" err="1"/>
              <a:t>repeas</a:t>
            </a:r>
            <a:r>
              <a:rPr lang="en-US" altLang="ja-JP" sz="1400" dirty="0"/>
              <a:t> for TARA Ocean (</a:t>
            </a:r>
            <a:r>
              <a:rPr lang="en-US" altLang="ja-JP" sz="1400" b="1" dirty="0"/>
              <a:t>c</a:t>
            </a:r>
            <a:r>
              <a:rPr lang="en-US" altLang="ja-JP" sz="1400" dirty="0"/>
              <a:t>) and (</a:t>
            </a:r>
            <a:r>
              <a:rPr lang="en-US" altLang="ja-JP" sz="1400" b="1" dirty="0"/>
              <a:t>d</a:t>
            </a:r>
            <a:r>
              <a:rPr lang="en-US" altLang="ja-JP" sz="1400" dirty="0"/>
              <a:t>).</a:t>
            </a:r>
            <a:endParaRPr kumimoji="1" lang="ja-JP" altLang="en-US" sz="14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13981" y="232034"/>
            <a:ext cx="26802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a</a:t>
            </a:r>
            <a:endParaRPr kumimoji="1" lang="ja-JP" altLang="en-US" sz="135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976250" y="155948"/>
            <a:ext cx="2792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b</a:t>
            </a:r>
            <a:endParaRPr kumimoji="1" lang="ja-JP" altLang="en-US" sz="1350" dirty="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513D3A4F-FE27-4D67-B6E1-D1CEE87A06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8949538"/>
              </p:ext>
            </p:extLst>
          </p:nvPr>
        </p:nvGraphicFramePr>
        <p:xfrm>
          <a:off x="4255494" y="3316496"/>
          <a:ext cx="4720593" cy="2284095"/>
        </p:xfrm>
        <a:graphic>
          <a:graphicData uri="http://schemas.openxmlformats.org/drawingml/2006/table">
            <a:tbl>
              <a:tblPr firstRow="1">
                <a:tableStyleId>{5940675A-B579-460E-94D1-54222C63F5DA}</a:tableStyleId>
              </a:tblPr>
              <a:tblGrid>
                <a:gridCol w="967615">
                  <a:extLst>
                    <a:ext uri="{9D8B030D-6E8A-4147-A177-3AD203B41FA5}">
                      <a16:colId xmlns:a16="http://schemas.microsoft.com/office/drawing/2014/main" val="3865828074"/>
                    </a:ext>
                  </a:extLst>
                </a:gridCol>
                <a:gridCol w="1206268">
                  <a:extLst>
                    <a:ext uri="{9D8B030D-6E8A-4147-A177-3AD203B41FA5}">
                      <a16:colId xmlns:a16="http://schemas.microsoft.com/office/drawing/2014/main" val="556590336"/>
                    </a:ext>
                  </a:extLst>
                </a:gridCol>
                <a:gridCol w="1329418">
                  <a:extLst>
                    <a:ext uri="{9D8B030D-6E8A-4147-A177-3AD203B41FA5}">
                      <a16:colId xmlns:a16="http://schemas.microsoft.com/office/drawing/2014/main" val="900343459"/>
                    </a:ext>
                  </a:extLst>
                </a:gridCol>
                <a:gridCol w="1217292">
                  <a:extLst>
                    <a:ext uri="{9D8B030D-6E8A-4147-A177-3AD203B41FA5}">
                      <a16:colId xmlns:a16="http://schemas.microsoft.com/office/drawing/2014/main" val="855305856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Filter size (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Maximum (TAG)n percentag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verage (TAG)n percentage of all sampl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umber of sampl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92125777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</a:rPr>
                        <a:t>0.22-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01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01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331984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0.8-20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02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01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01839437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0.8-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2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03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3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81625858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0.8-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46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09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199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24327747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0.8-2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14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1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6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7527846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</a:rPr>
                        <a:t>&gt;0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1.88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28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1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1549046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</a:rPr>
                        <a:t>&gt;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19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05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6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5263285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5-2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60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13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3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6550822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20-18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1.00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0.23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3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885862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</a:rPr>
                        <a:t>180-200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04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01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2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62363860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DE7F0418-15D8-433C-BD25-6C6421A0B8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0514226"/>
              </p:ext>
            </p:extLst>
          </p:nvPr>
        </p:nvGraphicFramePr>
        <p:xfrm>
          <a:off x="4255494" y="532116"/>
          <a:ext cx="4720593" cy="1398270"/>
        </p:xfrm>
        <a:graphic>
          <a:graphicData uri="http://schemas.openxmlformats.org/drawingml/2006/table">
            <a:tbl>
              <a:tblPr firstRow="1">
                <a:tableStyleId>{5940675A-B579-460E-94D1-54222C63F5DA}</a:tableStyleId>
              </a:tblPr>
              <a:tblGrid>
                <a:gridCol w="967615">
                  <a:extLst>
                    <a:ext uri="{9D8B030D-6E8A-4147-A177-3AD203B41FA5}">
                      <a16:colId xmlns:a16="http://schemas.microsoft.com/office/drawing/2014/main" val="2068052007"/>
                    </a:ext>
                  </a:extLst>
                </a:gridCol>
                <a:gridCol w="1206269">
                  <a:extLst>
                    <a:ext uri="{9D8B030D-6E8A-4147-A177-3AD203B41FA5}">
                      <a16:colId xmlns:a16="http://schemas.microsoft.com/office/drawing/2014/main" val="638176791"/>
                    </a:ext>
                  </a:extLst>
                </a:gridCol>
                <a:gridCol w="1338044">
                  <a:extLst>
                    <a:ext uri="{9D8B030D-6E8A-4147-A177-3AD203B41FA5}">
                      <a16:colId xmlns:a16="http://schemas.microsoft.com/office/drawing/2014/main" val="3972686812"/>
                    </a:ext>
                  </a:extLst>
                </a:gridCol>
                <a:gridCol w="1208665">
                  <a:extLst>
                    <a:ext uri="{9D8B030D-6E8A-4147-A177-3AD203B41FA5}">
                      <a16:colId xmlns:a16="http://schemas.microsoft.com/office/drawing/2014/main" val="781890704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Filter size (µm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Maximum (TAG)n percentag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Average (TAG)n percentage of all samples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Number of sampl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1334873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0.2-0.8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03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00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12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28245205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</a:rPr>
                        <a:t>0.8-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5.11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18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11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66188223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5-2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7.47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1.02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9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98126937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</a:rPr>
                        <a:t>20-10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1.4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12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10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2710107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</a:rPr>
                        <a:t>100-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23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0.07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</a:rPr>
                        <a:t>1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7335540"/>
                  </a:ext>
                </a:extLst>
              </a:tr>
            </a:tbl>
          </a:graphicData>
        </a:graphic>
      </p:graphicFrame>
      <p:grpSp>
        <p:nvGrpSpPr>
          <p:cNvPr id="21" name="グループ化 20"/>
          <p:cNvGrpSpPr/>
          <p:nvPr/>
        </p:nvGrpSpPr>
        <p:grpSpPr>
          <a:xfrm>
            <a:off x="875211" y="280314"/>
            <a:ext cx="2924942" cy="2880897"/>
            <a:chOff x="875211" y="280314"/>
            <a:chExt cx="2924942" cy="2880897"/>
          </a:xfrm>
        </p:grpSpPr>
        <p:pic>
          <p:nvPicPr>
            <p:cNvPr id="20" name="図 1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1" b="4166"/>
            <a:stretch/>
          </p:blipFill>
          <p:spPr>
            <a:xfrm>
              <a:off x="875211" y="280314"/>
              <a:ext cx="2924942" cy="2880897"/>
            </a:xfrm>
            <a:prstGeom prst="rect">
              <a:avLst/>
            </a:prstGeom>
          </p:spPr>
        </p:pic>
        <p:sp>
          <p:nvSpPr>
            <p:cNvPr id="6" name="正方形/長方形 5"/>
            <p:cNvSpPr/>
            <p:nvPr/>
          </p:nvSpPr>
          <p:spPr>
            <a:xfrm>
              <a:off x="3370820" y="1237975"/>
              <a:ext cx="390144" cy="2255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7" name="グループ化 6"/>
          <p:cNvGrpSpPr/>
          <p:nvPr/>
        </p:nvGrpSpPr>
        <p:grpSpPr>
          <a:xfrm>
            <a:off x="858244" y="3616416"/>
            <a:ext cx="2950668" cy="2956913"/>
            <a:chOff x="5969479" y="3435261"/>
            <a:chExt cx="2950668" cy="2956913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23" b="3319"/>
            <a:stretch/>
          </p:blipFill>
          <p:spPr>
            <a:xfrm>
              <a:off x="5969479" y="3435261"/>
              <a:ext cx="2950668" cy="2956913"/>
            </a:xfrm>
            <a:prstGeom prst="rect">
              <a:avLst/>
            </a:prstGeom>
          </p:spPr>
        </p:pic>
        <p:sp>
          <p:nvSpPr>
            <p:cNvPr id="13" name="正方形/長方形 12"/>
            <p:cNvSpPr/>
            <p:nvPr/>
          </p:nvSpPr>
          <p:spPr>
            <a:xfrm>
              <a:off x="8436363" y="4164613"/>
              <a:ext cx="390144" cy="2255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5" name="テキスト ボックス 14"/>
          <p:cNvSpPr txBox="1"/>
          <p:nvPr/>
        </p:nvSpPr>
        <p:spPr>
          <a:xfrm>
            <a:off x="302097" y="3457541"/>
            <a:ext cx="25840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c</a:t>
            </a:r>
            <a:endParaRPr kumimoji="1" lang="ja-JP" altLang="en-US" sz="135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864366" y="3381455"/>
            <a:ext cx="27603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d</a:t>
            </a:r>
            <a:endParaRPr kumimoji="1" lang="ja-JP" altLang="en-US" sz="1350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577869" y="6560658"/>
            <a:ext cx="10326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Filter size (µm)</a:t>
            </a:r>
            <a:endParaRPr kumimoji="1" lang="ja-JP" altLang="en-US" sz="11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577869" y="3105867"/>
            <a:ext cx="10326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Filter size (µm)</a:t>
            </a:r>
            <a:endParaRPr kumimoji="1" lang="ja-JP" altLang="en-US" sz="1100" dirty="0"/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-9541" y="1332722"/>
            <a:ext cx="12618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(TAG)n percentage</a:t>
            </a:r>
            <a:endParaRPr kumimoji="1" lang="ja-JP" altLang="en-US" sz="1100" dirty="0"/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-9541" y="4956354"/>
            <a:ext cx="12618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(TAG)n percentage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4635069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3800153" y="5855429"/>
            <a:ext cx="52608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Supplementary Information 6. The original image of Figure 10c (Southern blot of TAG repeats)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864366" y="3381455"/>
            <a:ext cx="27603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d</a:t>
            </a:r>
            <a:endParaRPr kumimoji="1" lang="ja-JP" altLang="en-US" sz="135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577869" y="3105867"/>
            <a:ext cx="10326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Filter size (µm)</a:t>
            </a:r>
            <a:endParaRPr kumimoji="1" lang="ja-JP" altLang="en-US" sz="1100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9CF27DCA-4DE0-654F-8D7F-28F103DF1FC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092" t="13660" r="38725" b="16377"/>
          <a:stretch/>
        </p:blipFill>
        <p:spPr>
          <a:xfrm>
            <a:off x="1577869" y="1335639"/>
            <a:ext cx="3857160" cy="4264951"/>
          </a:xfrm>
          <a:prstGeom prst="rect">
            <a:avLst/>
          </a:prstGeom>
        </p:spPr>
      </p:pic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D4C6FFAE-3541-ED48-BC32-13E9D2104A74}"/>
              </a:ext>
            </a:extLst>
          </p:cNvPr>
          <p:cNvGrpSpPr/>
          <p:nvPr/>
        </p:nvGrpSpPr>
        <p:grpSpPr>
          <a:xfrm>
            <a:off x="1364320" y="1068139"/>
            <a:ext cx="3857160" cy="759368"/>
            <a:chOff x="1991044" y="781512"/>
            <a:chExt cx="2024110" cy="759368"/>
          </a:xfrm>
        </p:grpSpPr>
        <p:sp>
          <p:nvSpPr>
            <p:cNvPr id="23" name="テキスト ボックス 72">
              <a:extLst>
                <a:ext uri="{FF2B5EF4-FFF2-40B4-BE49-F238E27FC236}">
                  <a16:creationId xmlns:a16="http://schemas.microsoft.com/office/drawing/2014/main" id="{0C531D37-3EBF-3A4B-BC02-A024016603E1}"/>
                </a:ext>
              </a:extLst>
            </p:cNvPr>
            <p:cNvSpPr txBox="1"/>
            <p:nvPr/>
          </p:nvSpPr>
          <p:spPr>
            <a:xfrm>
              <a:off x="1991044" y="1186814"/>
              <a:ext cx="619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79">
              <a:extLst>
                <a:ext uri="{FF2B5EF4-FFF2-40B4-BE49-F238E27FC236}">
                  <a16:creationId xmlns:a16="http://schemas.microsoft.com/office/drawing/2014/main" id="{9A00FB17-F582-F04E-A8AB-BEFFDB7F7FCE}"/>
                </a:ext>
              </a:extLst>
            </p:cNvPr>
            <p:cNvSpPr txBox="1"/>
            <p:nvPr/>
          </p:nvSpPr>
          <p:spPr>
            <a:xfrm rot="18637527">
              <a:off x="2521417" y="1177345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80">
              <a:extLst>
                <a:ext uri="{FF2B5EF4-FFF2-40B4-BE49-F238E27FC236}">
                  <a16:creationId xmlns:a16="http://schemas.microsoft.com/office/drawing/2014/main" id="{9C198721-4F2C-6F46-9F42-777B9C8854B6}"/>
                </a:ext>
              </a:extLst>
            </p:cNvPr>
            <p:cNvSpPr txBox="1"/>
            <p:nvPr/>
          </p:nvSpPr>
          <p:spPr>
            <a:xfrm rot="18637527">
              <a:off x="3172196" y="1038085"/>
              <a:ext cx="7593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TV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(TAG)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81">
              <a:extLst>
                <a:ext uri="{FF2B5EF4-FFF2-40B4-BE49-F238E27FC236}">
                  <a16:creationId xmlns:a16="http://schemas.microsoft.com/office/drawing/2014/main" id="{31915524-EE9D-6A47-93F2-2DACD70CC621}"/>
                </a:ext>
              </a:extLst>
            </p:cNvPr>
            <p:cNvSpPr txBox="1"/>
            <p:nvPr/>
          </p:nvSpPr>
          <p:spPr>
            <a:xfrm rot="18637527">
              <a:off x="3375802" y="1038085"/>
              <a:ext cx="7593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TV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(TAG)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82">
              <a:extLst>
                <a:ext uri="{FF2B5EF4-FFF2-40B4-BE49-F238E27FC236}">
                  <a16:creationId xmlns:a16="http://schemas.microsoft.com/office/drawing/2014/main" id="{8E04DA60-BA03-FB42-9E2E-A9197D19A6C4}"/>
                </a:ext>
              </a:extLst>
            </p:cNvPr>
            <p:cNvSpPr txBox="1"/>
            <p:nvPr/>
          </p:nvSpPr>
          <p:spPr>
            <a:xfrm rot="18637527">
              <a:off x="3625102" y="1112207"/>
              <a:ext cx="5338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E. coli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83">
              <a:extLst>
                <a:ext uri="{FF2B5EF4-FFF2-40B4-BE49-F238E27FC236}">
                  <a16:creationId xmlns:a16="http://schemas.microsoft.com/office/drawing/2014/main" id="{29422DAB-C9FF-984F-9DC8-861D2510A404}"/>
                </a:ext>
              </a:extLst>
            </p:cNvPr>
            <p:cNvSpPr txBox="1"/>
            <p:nvPr/>
          </p:nvSpPr>
          <p:spPr>
            <a:xfrm rot="18637527">
              <a:off x="2717766" y="1177345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84">
              <a:extLst>
                <a:ext uri="{FF2B5EF4-FFF2-40B4-BE49-F238E27FC236}">
                  <a16:creationId xmlns:a16="http://schemas.microsoft.com/office/drawing/2014/main" id="{7844DC67-E820-9B4A-A1C6-7D6D4429D851}"/>
                </a:ext>
              </a:extLst>
            </p:cNvPr>
            <p:cNvSpPr txBox="1"/>
            <p:nvPr/>
          </p:nvSpPr>
          <p:spPr>
            <a:xfrm rot="18637527">
              <a:off x="2904589" y="115488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#1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85">
              <a:extLst>
                <a:ext uri="{FF2B5EF4-FFF2-40B4-BE49-F238E27FC236}">
                  <a16:creationId xmlns:a16="http://schemas.microsoft.com/office/drawing/2014/main" id="{40C3B60C-950A-5C41-8ACB-1424842EC9A3}"/>
                </a:ext>
              </a:extLst>
            </p:cNvPr>
            <p:cNvSpPr txBox="1"/>
            <p:nvPr/>
          </p:nvSpPr>
          <p:spPr>
            <a:xfrm rot="18637527">
              <a:off x="3083970" y="1154883"/>
              <a:ext cx="4026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#1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64599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F425E50-1677-4E83-9DAC-B73633DFC0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383" y="779393"/>
            <a:ext cx="7775233" cy="5299213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057AF89-4446-4FCA-8A0A-BC03B5D13741}"/>
              </a:ext>
            </a:extLst>
          </p:cNvPr>
          <p:cNvSpPr txBox="1"/>
          <p:nvPr/>
        </p:nvSpPr>
        <p:spPr>
          <a:xfrm>
            <a:off x="3883185" y="6230002"/>
            <a:ext cx="52608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Supplementary </a:t>
            </a:r>
            <a:r>
              <a:rPr lang="en-US" altLang="ja-JP" sz="1400"/>
              <a:t>Information 8. </a:t>
            </a:r>
            <a:r>
              <a:rPr lang="en-US" altLang="ja-JP" sz="1400" dirty="0"/>
              <a:t>In silico probes associated with the environmental factors on a digital DNA chip</a:t>
            </a:r>
          </a:p>
        </p:txBody>
      </p:sp>
    </p:spTree>
    <p:extLst>
      <p:ext uri="{BB962C8B-B14F-4D97-AF65-F5344CB8AC3E}">
        <p14:creationId xmlns:p14="http://schemas.microsoft.com/office/powerpoint/2010/main" val="1725616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8</TotalTime>
  <Words>738</Words>
  <Application>Microsoft Macintosh PowerPoint</Application>
  <PresentationFormat>画面に合わせる (4:3)</PresentationFormat>
  <Paragraphs>170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7" baseType="lpstr">
      <vt:lpstr>ＭＳ Ｐゴシック</vt:lpstr>
      <vt:lpstr>ＭＳ 明朝</vt:lpstr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武 和敏</dc:creator>
  <cp:lastModifiedBy>Kazutoshi Yoshitake</cp:lastModifiedBy>
  <cp:revision>8</cp:revision>
  <dcterms:created xsi:type="dcterms:W3CDTF">2020-08-19T11:13:32Z</dcterms:created>
  <dcterms:modified xsi:type="dcterms:W3CDTF">2021-05-17T16:04:53Z</dcterms:modified>
</cp:coreProperties>
</file>